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45" d="100"/>
          <a:sy n="45" d="100"/>
        </p:scale>
        <p:origin x="-1592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56C03A-44A9-9F4F-8279-B34EF490ED43}" type="datetimeFigureOut">
              <a:rPr kumimoji="1" lang="zh-CN" altLang="en-US" smtClean="0"/>
              <a:t>20/8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E9DFD-E011-1B43-A370-5629C182977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78721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56C03A-44A9-9F4F-8279-B34EF490ED43}" type="datetimeFigureOut">
              <a:rPr kumimoji="1" lang="zh-CN" altLang="en-US" smtClean="0"/>
              <a:t>20/8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E9DFD-E011-1B43-A370-5629C182977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646935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56C03A-44A9-9F4F-8279-B34EF490ED43}" type="datetimeFigureOut">
              <a:rPr kumimoji="1" lang="zh-CN" altLang="en-US" smtClean="0"/>
              <a:t>20/8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E9DFD-E011-1B43-A370-5629C182977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501645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56C03A-44A9-9F4F-8279-B34EF490ED43}" type="datetimeFigureOut">
              <a:rPr kumimoji="1" lang="zh-CN" altLang="en-US" smtClean="0"/>
              <a:t>20/8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E9DFD-E011-1B43-A370-5629C182977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97852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56C03A-44A9-9F4F-8279-B34EF490ED43}" type="datetimeFigureOut">
              <a:rPr kumimoji="1" lang="zh-CN" altLang="en-US" smtClean="0"/>
              <a:t>20/8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E9DFD-E011-1B43-A370-5629C182977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918134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56C03A-44A9-9F4F-8279-B34EF490ED43}" type="datetimeFigureOut">
              <a:rPr kumimoji="1" lang="zh-CN" altLang="en-US" smtClean="0"/>
              <a:t>20/8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E9DFD-E011-1B43-A370-5629C182977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72547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56C03A-44A9-9F4F-8279-B34EF490ED43}" type="datetimeFigureOut">
              <a:rPr kumimoji="1" lang="zh-CN" altLang="en-US" smtClean="0"/>
              <a:t>20/8/18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E9DFD-E011-1B43-A370-5629C182977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487699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56C03A-44A9-9F4F-8279-B34EF490ED43}" type="datetimeFigureOut">
              <a:rPr kumimoji="1" lang="zh-CN" altLang="en-US" smtClean="0"/>
              <a:t>20/8/18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E9DFD-E011-1B43-A370-5629C182977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90012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56C03A-44A9-9F4F-8279-B34EF490ED43}" type="datetimeFigureOut">
              <a:rPr kumimoji="1" lang="zh-CN" altLang="en-US" smtClean="0"/>
              <a:t>20/8/18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E9DFD-E011-1B43-A370-5629C182977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233077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56C03A-44A9-9F4F-8279-B34EF490ED43}" type="datetimeFigureOut">
              <a:rPr kumimoji="1" lang="zh-CN" altLang="en-US" smtClean="0"/>
              <a:t>20/8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E9DFD-E011-1B43-A370-5629C182977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403832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56C03A-44A9-9F4F-8279-B34EF490ED43}" type="datetimeFigureOut">
              <a:rPr kumimoji="1" lang="zh-CN" altLang="en-US" smtClean="0"/>
              <a:t>20/8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E9DFD-E011-1B43-A370-5629C182977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825156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56C03A-44A9-9F4F-8279-B34EF490ED43}" type="datetimeFigureOut">
              <a:rPr kumimoji="1" lang="zh-CN" altLang="en-US" smtClean="0"/>
              <a:t>20/8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CE9DFD-E011-1B43-A370-5629C182977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02113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="" xmlns:a16="http://schemas.microsoft.com/office/drawing/2014/main" id="{7D712E91-58EE-4F30-8C20-463680ACFF54}"/>
              </a:ext>
            </a:extLst>
          </p:cNvPr>
          <p:cNvSpPr txBox="1"/>
          <p:nvPr/>
        </p:nvSpPr>
        <p:spPr>
          <a:xfrm>
            <a:off x="78794" y="0"/>
            <a:ext cx="30301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Arial"/>
                <a:cs typeface="Arial"/>
              </a:rPr>
              <a:t>Supplementary Table 1</a:t>
            </a:r>
            <a:endParaRPr lang="zh-CN" altLang="en-US" sz="1400" b="1" dirty="0">
              <a:latin typeface="Arial"/>
              <a:cs typeface="Arial"/>
            </a:endParaRPr>
          </a:p>
        </p:txBody>
      </p:sp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14671441"/>
              </p:ext>
            </p:extLst>
          </p:nvPr>
        </p:nvGraphicFramePr>
        <p:xfrm>
          <a:off x="826770" y="634682"/>
          <a:ext cx="4991100" cy="2164080"/>
        </p:xfrm>
        <a:graphic>
          <a:graphicData uri="http://schemas.openxmlformats.org/drawingml/2006/table">
            <a:tbl>
              <a:tblPr/>
              <a:tblGrid>
                <a:gridCol w="2057400"/>
                <a:gridCol w="2933700"/>
              </a:tblGrid>
              <a:tr h="165100"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等线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nse (5'-3')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iControl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UCUCCGAACGUGUCACGUTT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NF181#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AUGCCUUGCCAUCACCUU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NF181#2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AGCAACACCGACUGGAGA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NF181#</a:t>
                      </a:r>
                      <a:r>
                        <a:rPr lang="en-US" altLang="zh-CN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 (</a:t>
                      </a:r>
                      <a:r>
                        <a:rPr lang="en-US" altLang="zh-CN" sz="11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viad</a:t>
                      </a:r>
                      <a:r>
                        <a:rPr lang="en-US" altLang="zh-CN" sz="11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study</a:t>
                      </a:r>
                      <a:r>
                        <a:rPr lang="en-US" altLang="zh-CN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)</a:t>
                      </a:r>
                      <a:endParaRPr lang="en-US" altLang="zh-CN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GCTGCCCACTGATGACGACA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NF181#</a:t>
                      </a:r>
                      <a:r>
                        <a:rPr lang="en-US" altLang="zh-CN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 (</a:t>
                      </a:r>
                      <a:r>
                        <a:rPr lang="en-US" altLang="zh-CN" sz="11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viad</a:t>
                      </a:r>
                      <a:r>
                        <a:rPr lang="en-US" altLang="zh-CN" sz="11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study</a:t>
                      </a:r>
                      <a:r>
                        <a:rPr lang="en-US" altLang="zh-CN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)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CTCTGCGTCTTCCTTATTAA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NF181#</a:t>
                      </a:r>
                      <a:r>
                        <a:rPr lang="en-US" altLang="zh-CN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 (</a:t>
                      </a:r>
                      <a:r>
                        <a:rPr lang="en-US" altLang="zh-CN" sz="11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viad</a:t>
                      </a:r>
                      <a:r>
                        <a:rPr lang="en-US" altLang="zh-CN" sz="11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study</a:t>
                      </a:r>
                      <a:r>
                        <a:rPr lang="en-US" altLang="zh-CN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)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CCCACTGATGACGACACTTA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NF181-homo-UTR3-504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CCUCUGCGUCUUCCUUAUTT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NF181-homo-UTR3-558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CCUGAGGCUGUAUUGAUCTT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NF181-homo-UTR3-608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CAGGUCUCUACUUCUGUUTT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811009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9</Words>
  <Application>Microsoft Macintosh PowerPoint</Application>
  <PresentationFormat>全屏显示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Company>Karolinska Institute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uang Ting</dc:creator>
  <cp:lastModifiedBy>Zhuang Ting</cp:lastModifiedBy>
  <cp:revision>1</cp:revision>
  <dcterms:created xsi:type="dcterms:W3CDTF">2020-08-17T16:06:26Z</dcterms:created>
  <dcterms:modified xsi:type="dcterms:W3CDTF">2020-08-17T16:06:53Z</dcterms:modified>
</cp:coreProperties>
</file>